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5" d="100"/>
          <a:sy n="65" d="100"/>
        </p:scale>
        <p:origin x="91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fr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fr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BAD32F-E9DC-40AC-A26E-72B99A7DD789}" type="datetimeFigureOut">
              <a:rPr lang="fr-CA" smtClean="0"/>
              <a:t>2025-03-17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C7028-6CA7-45E8-B8C4-0F3B8B06B123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2554738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BAD32F-E9DC-40AC-A26E-72B99A7DD789}" type="datetimeFigureOut">
              <a:rPr lang="fr-CA" smtClean="0"/>
              <a:t>2025-03-17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C7028-6CA7-45E8-B8C4-0F3B8B06B123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9735980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fr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BAD32F-E9DC-40AC-A26E-72B99A7DD789}" type="datetimeFigureOut">
              <a:rPr lang="fr-CA" smtClean="0"/>
              <a:t>2025-03-17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C7028-6CA7-45E8-B8C4-0F3B8B06B123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40395253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BAD32F-E9DC-40AC-A26E-72B99A7DD789}" type="datetimeFigureOut">
              <a:rPr lang="fr-CA" smtClean="0"/>
              <a:t>2025-03-17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C7028-6CA7-45E8-B8C4-0F3B8B06B123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0863321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fr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BAD32F-E9DC-40AC-A26E-72B99A7DD789}" type="datetimeFigureOut">
              <a:rPr lang="fr-CA" smtClean="0"/>
              <a:t>2025-03-17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C7028-6CA7-45E8-B8C4-0F3B8B06B123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6610654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BAD32F-E9DC-40AC-A26E-72B99A7DD789}" type="datetimeFigureOut">
              <a:rPr lang="fr-CA" smtClean="0"/>
              <a:t>2025-03-17</a:t>
            </a:fld>
            <a:endParaRPr lang="fr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C7028-6CA7-45E8-B8C4-0F3B8B06B123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080653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fr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BAD32F-E9DC-40AC-A26E-72B99A7DD789}" type="datetimeFigureOut">
              <a:rPr lang="fr-CA" smtClean="0"/>
              <a:t>2025-03-17</a:t>
            </a:fld>
            <a:endParaRPr lang="fr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C7028-6CA7-45E8-B8C4-0F3B8B06B123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0120145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BAD32F-E9DC-40AC-A26E-72B99A7DD789}" type="datetimeFigureOut">
              <a:rPr lang="fr-CA" smtClean="0"/>
              <a:t>2025-03-17</a:t>
            </a:fld>
            <a:endParaRPr lang="fr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C7028-6CA7-45E8-B8C4-0F3B8B06B123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4685403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BAD32F-E9DC-40AC-A26E-72B99A7DD789}" type="datetimeFigureOut">
              <a:rPr lang="fr-CA" smtClean="0"/>
              <a:t>2025-03-17</a:t>
            </a:fld>
            <a:endParaRPr lang="fr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C7028-6CA7-45E8-B8C4-0F3B8B06B123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7781616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r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BAD32F-E9DC-40AC-A26E-72B99A7DD789}" type="datetimeFigureOut">
              <a:rPr lang="fr-CA" smtClean="0"/>
              <a:t>2025-03-17</a:t>
            </a:fld>
            <a:endParaRPr lang="fr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C7028-6CA7-45E8-B8C4-0F3B8B06B123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6733454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r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BAD32F-E9DC-40AC-A26E-72B99A7DD789}" type="datetimeFigureOut">
              <a:rPr lang="fr-CA" smtClean="0"/>
              <a:t>2025-03-17</a:t>
            </a:fld>
            <a:endParaRPr lang="fr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C7028-6CA7-45E8-B8C4-0F3B8B06B123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8307834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fr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BAD32F-E9DC-40AC-A26E-72B99A7DD789}" type="datetimeFigureOut">
              <a:rPr lang="fr-CA" smtClean="0"/>
              <a:t>2025-03-17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CC7028-6CA7-45E8-B8C4-0F3B8B06B123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4119314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2198254" y="547363"/>
            <a:ext cx="755534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>
                <a:latin typeface="Palatino Linotype" panose="02040502050505030304" pitchFamily="18" charset="0"/>
                <a:ea typeface="Calibri" panose="020F0502020204030204" pitchFamily="34" charset="0"/>
              </a:rPr>
              <a:t>Table S1: </a:t>
            </a:r>
            <a:r>
              <a:rPr lang="en-US" dirty="0">
                <a:latin typeface="Palatino Linotype" panose="02040502050505030304" pitchFamily="18" charset="0"/>
                <a:ea typeface="Calibri" panose="020F0502020204030204" pitchFamily="34" charset="0"/>
              </a:rPr>
              <a:t>Research material concentration related to polyphenol content.</a:t>
            </a:r>
            <a:endParaRPr lang="fr-CA" dirty="0">
              <a:latin typeface="Palatino Linotype" panose="02040502050505030304" pitchFamily="18" charset="0"/>
            </a:endParaRPr>
          </a:p>
        </p:txBody>
      </p:sp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08924929"/>
              </p:ext>
            </p:extLst>
          </p:nvPr>
        </p:nvGraphicFramePr>
        <p:xfrm>
          <a:off x="637312" y="1080653"/>
          <a:ext cx="10677232" cy="4636650"/>
        </p:xfrm>
        <a:graphic>
          <a:graphicData uri="http://schemas.openxmlformats.org/drawingml/2006/table">
            <a:tbl>
              <a:tblPr firstRow="1" firstCol="1" bandRow="1"/>
              <a:tblGrid>
                <a:gridCol w="903410">
                  <a:extLst>
                    <a:ext uri="{9D8B030D-6E8A-4147-A177-3AD203B41FA5}">
                      <a16:colId xmlns:a16="http://schemas.microsoft.com/office/drawing/2014/main" val="338198488"/>
                    </a:ext>
                  </a:extLst>
                </a:gridCol>
                <a:gridCol w="904472">
                  <a:extLst>
                    <a:ext uri="{9D8B030D-6E8A-4147-A177-3AD203B41FA5}">
                      <a16:colId xmlns:a16="http://schemas.microsoft.com/office/drawing/2014/main" val="437744201"/>
                    </a:ext>
                  </a:extLst>
                </a:gridCol>
                <a:gridCol w="904472">
                  <a:extLst>
                    <a:ext uri="{9D8B030D-6E8A-4147-A177-3AD203B41FA5}">
                      <a16:colId xmlns:a16="http://schemas.microsoft.com/office/drawing/2014/main" val="2127051218"/>
                    </a:ext>
                  </a:extLst>
                </a:gridCol>
                <a:gridCol w="904472">
                  <a:extLst>
                    <a:ext uri="{9D8B030D-6E8A-4147-A177-3AD203B41FA5}">
                      <a16:colId xmlns:a16="http://schemas.microsoft.com/office/drawing/2014/main" val="2071552689"/>
                    </a:ext>
                  </a:extLst>
                </a:gridCol>
                <a:gridCol w="1054331">
                  <a:extLst>
                    <a:ext uri="{9D8B030D-6E8A-4147-A177-3AD203B41FA5}">
                      <a16:colId xmlns:a16="http://schemas.microsoft.com/office/drawing/2014/main" val="1022675448"/>
                    </a:ext>
                  </a:extLst>
                </a:gridCol>
                <a:gridCol w="1054331">
                  <a:extLst>
                    <a:ext uri="{9D8B030D-6E8A-4147-A177-3AD203B41FA5}">
                      <a16:colId xmlns:a16="http://schemas.microsoft.com/office/drawing/2014/main" val="2494113121"/>
                    </a:ext>
                  </a:extLst>
                </a:gridCol>
                <a:gridCol w="904472">
                  <a:extLst>
                    <a:ext uri="{9D8B030D-6E8A-4147-A177-3AD203B41FA5}">
                      <a16:colId xmlns:a16="http://schemas.microsoft.com/office/drawing/2014/main" val="1246509539"/>
                    </a:ext>
                  </a:extLst>
                </a:gridCol>
                <a:gridCol w="969305">
                  <a:extLst>
                    <a:ext uri="{9D8B030D-6E8A-4147-A177-3AD203B41FA5}">
                      <a16:colId xmlns:a16="http://schemas.microsoft.com/office/drawing/2014/main" val="3393240438"/>
                    </a:ext>
                  </a:extLst>
                </a:gridCol>
                <a:gridCol w="969305">
                  <a:extLst>
                    <a:ext uri="{9D8B030D-6E8A-4147-A177-3AD203B41FA5}">
                      <a16:colId xmlns:a16="http://schemas.microsoft.com/office/drawing/2014/main" val="1160525814"/>
                    </a:ext>
                  </a:extLst>
                </a:gridCol>
                <a:gridCol w="1054331">
                  <a:extLst>
                    <a:ext uri="{9D8B030D-6E8A-4147-A177-3AD203B41FA5}">
                      <a16:colId xmlns:a16="http://schemas.microsoft.com/office/drawing/2014/main" val="2437180429"/>
                    </a:ext>
                  </a:extLst>
                </a:gridCol>
                <a:gridCol w="1054331">
                  <a:extLst>
                    <a:ext uri="{9D8B030D-6E8A-4147-A177-3AD203B41FA5}">
                      <a16:colId xmlns:a16="http://schemas.microsoft.com/office/drawing/2014/main" val="4151192674"/>
                    </a:ext>
                  </a:extLst>
                </a:gridCol>
              </a:tblGrid>
              <a:tr h="538442">
                <a:tc row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b="1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utter content </a:t>
                      </a:r>
                      <a:endParaRPr lang="fr-CA" sz="14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b="1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mg)</a:t>
                      </a:r>
                      <a:endParaRPr lang="fr-CA" sz="14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b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oue</a:t>
                      </a:r>
                      <a:r>
                        <a:rPr lang="fr-BE" sz="1400" b="1" baseline="-25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fr-CA" sz="1400" b="1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b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oba</a:t>
                      </a:r>
                      <a:r>
                        <a:rPr lang="fr-BE" sz="1400" b="1" baseline="-25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fr-CA" sz="1400" b="1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b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oba</a:t>
                      </a:r>
                      <a:r>
                        <a:rPr lang="fr-BE" sz="1400" b="1" baseline="-25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fr-CA" sz="1400" b="1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b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Kadi</a:t>
                      </a:r>
                      <a:r>
                        <a:rPr lang="fr-BE" sz="1400" b="1" baseline="-25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fr-CA" sz="1400" b="1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b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aya</a:t>
                      </a:r>
                      <a:r>
                        <a:rPr lang="fr-BE" sz="1400" b="1" baseline="-25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fr-CA" sz="1400" b="1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b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iss</a:t>
                      </a:r>
                      <a:r>
                        <a:rPr lang="fr-BE" sz="1400" b="1" baseline="-25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fr-CA" sz="1400" b="1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b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Yate</a:t>
                      </a:r>
                      <a:r>
                        <a:rPr lang="fr-BE" sz="1400" b="1" baseline="-25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fr-CA" sz="1400" b="1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b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rude Ind.</a:t>
                      </a:r>
                      <a:endParaRPr lang="fr-CA" sz="1400" b="1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b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fined</a:t>
                      </a:r>
                      <a:endParaRPr lang="fr-CA" sz="1400" b="1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b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Kariten</a:t>
                      </a:r>
                      <a:endParaRPr lang="fr-CA" sz="1400" b="1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17391054"/>
                  </a:ext>
                </a:extLst>
              </a:tr>
              <a:tr h="269222">
                <a:tc vMerge="1">
                  <a:txBody>
                    <a:bodyPr/>
                    <a:lstStyle/>
                    <a:p>
                      <a:endParaRPr lang="fr-CA"/>
                    </a:p>
                  </a:txBody>
                  <a:tcPr/>
                </a:tc>
                <a:tc gridSpan="10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b="1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otal </a:t>
                      </a:r>
                      <a:r>
                        <a:rPr lang="fr-BE" sz="1400" b="1" dirty="0" err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olyphenol</a:t>
                      </a:r>
                      <a:r>
                        <a:rPr lang="fr-BE" sz="1400" b="1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content (ppm)</a:t>
                      </a:r>
                      <a:endParaRPr lang="fr-CA" sz="14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CA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86728435"/>
                  </a:ext>
                </a:extLst>
              </a:tr>
              <a:tr h="269222">
                <a:tc vMerge="1">
                  <a:txBody>
                    <a:bodyPr/>
                    <a:lstStyle/>
                    <a:p>
                      <a:endParaRPr lang="fr-CA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b="1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5.12</a:t>
                      </a:r>
                      <a:endParaRPr lang="fr-CA" sz="14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b="1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2.98</a:t>
                      </a:r>
                      <a:endParaRPr lang="fr-CA" sz="14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b="1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1.13</a:t>
                      </a:r>
                      <a:endParaRPr lang="fr-CA" sz="14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b="1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0.74</a:t>
                      </a:r>
                      <a:endParaRPr lang="fr-CA" sz="14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b="1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9.22</a:t>
                      </a:r>
                      <a:endParaRPr lang="fr-CA" sz="14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b="1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4.16</a:t>
                      </a:r>
                      <a:endParaRPr lang="fr-CA" sz="14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b="1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2.99</a:t>
                      </a:r>
                      <a:endParaRPr lang="fr-CA" sz="14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b="1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8.15</a:t>
                      </a:r>
                      <a:endParaRPr lang="fr-CA" sz="14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b="1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2.77</a:t>
                      </a:r>
                      <a:endParaRPr lang="fr-CA" sz="14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b="1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4.81</a:t>
                      </a:r>
                      <a:endParaRPr lang="fr-CA" sz="14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60710128"/>
                  </a:ext>
                </a:extLst>
              </a:tr>
              <a:tr h="32910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CA" sz="1400" b="1"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gridSpan="10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lated polyphenol content (ppm) for antioxidant assays (ABTS/DPPH tests)</a:t>
                      </a:r>
                      <a:endParaRPr lang="fr-CA" sz="14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CA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10935029"/>
                  </a:ext>
                </a:extLst>
              </a:tr>
              <a:tr h="26922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 .0</a:t>
                      </a:r>
                      <a:endParaRPr lang="fr-CA" sz="140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.71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38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27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.64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.15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85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.98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.29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97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49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72294128"/>
                  </a:ext>
                </a:extLst>
              </a:tr>
              <a:tr h="26922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.0 </a:t>
                      </a:r>
                      <a:endParaRPr lang="fr-CA" sz="140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80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2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85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.43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.77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57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.32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53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31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9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57480343"/>
                  </a:ext>
                </a:extLst>
              </a:tr>
              <a:tr h="26922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0 </a:t>
                      </a:r>
                      <a:endParaRPr lang="fr-CA" sz="140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0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6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2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21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38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28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66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76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66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50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00080504"/>
                  </a:ext>
                </a:extLst>
              </a:tr>
              <a:tr h="26922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5</a:t>
                      </a:r>
                      <a:endParaRPr lang="fr-CA" sz="140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5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23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21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61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69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4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83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38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33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25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20442895"/>
                  </a:ext>
                </a:extLst>
              </a:tr>
              <a:tr h="26922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5 </a:t>
                      </a:r>
                      <a:endParaRPr lang="fr-CA" sz="140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5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2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2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6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7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1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8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4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3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2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90080892"/>
                  </a:ext>
                </a:extLst>
              </a:tr>
              <a:tr h="269222">
                <a:tc gridSpan="11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lated polyphenol content (ppm) for (photo)protective assays, acellular model</a:t>
                      </a:r>
                      <a:endParaRPr lang="fr-CA" sz="14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CA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67497786"/>
                  </a:ext>
                </a:extLst>
              </a:tr>
              <a:tr h="26922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.0 </a:t>
                      </a:r>
                      <a:endParaRPr lang="fr-CA" sz="140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201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02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94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270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308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63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369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70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46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10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85275140"/>
                  </a:ext>
                </a:extLst>
              </a:tr>
              <a:tr h="26922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0</a:t>
                      </a:r>
                      <a:endParaRPr lang="fr-CA" sz="140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00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51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47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35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54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31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84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85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73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55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01901353"/>
                  </a:ext>
                </a:extLst>
              </a:tr>
              <a:tr h="26922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 </a:t>
                      </a:r>
                      <a:endParaRPr lang="fr-CA" sz="140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10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5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5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13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15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3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18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8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7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6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70225671"/>
                  </a:ext>
                </a:extLst>
              </a:tr>
              <a:tr h="269222">
                <a:tc gridSpan="11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lated polyphenol content (ppm) for (photo)protective assays, cellular model</a:t>
                      </a:r>
                      <a:endParaRPr lang="fr-CA" sz="1400" b="1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CA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08415553"/>
                  </a:ext>
                </a:extLst>
              </a:tr>
              <a:tr h="26922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.0</a:t>
                      </a:r>
                      <a:endParaRPr lang="fr-CA" sz="140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80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2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85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.43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.77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57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.32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53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31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9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28150614"/>
                  </a:ext>
                </a:extLst>
              </a:tr>
              <a:tr h="26922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0</a:t>
                      </a:r>
                      <a:endParaRPr lang="fr-CA" sz="140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0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6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2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21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38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28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66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76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66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BE" sz="14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50</a:t>
                      </a:r>
                      <a:endParaRPr lang="fr-CA" sz="1400" dirty="0"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19228653"/>
                  </a:ext>
                </a:extLst>
              </a:tr>
            </a:tbl>
          </a:graphicData>
        </a:graphic>
      </p:graphicFrame>
      <p:sp>
        <p:nvSpPr>
          <p:cNvPr id="2" name="Rectangle 1"/>
          <p:cNvSpPr/>
          <p:nvPr/>
        </p:nvSpPr>
        <p:spPr>
          <a:xfrm>
            <a:off x="4917594" y="5711374"/>
            <a:ext cx="1931939" cy="33977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lnSpc>
                <a:spcPct val="150000"/>
              </a:lnSpc>
              <a:spcAft>
                <a:spcPts val="0"/>
              </a:spcAft>
            </a:pP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rude Ind.: Crude Industrial</a:t>
            </a:r>
            <a:endParaRPr lang="fr-CA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685341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9</TotalTime>
  <Words>206</Words>
  <Application>Microsoft Office PowerPoint</Application>
  <PresentationFormat>Grand écran</PresentationFormat>
  <Paragraphs>138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imes New Roman</vt:lpstr>
      <vt:lpstr>Office Them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oumbri</dc:creator>
  <cp:lastModifiedBy>Mouithys-Mickalad Olivia</cp:lastModifiedBy>
  <cp:revision>7</cp:revision>
  <dcterms:created xsi:type="dcterms:W3CDTF">2025-02-10T09:16:29Z</dcterms:created>
  <dcterms:modified xsi:type="dcterms:W3CDTF">2025-03-17T18:32:42Z</dcterms:modified>
</cp:coreProperties>
</file>